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5" d="100"/>
          <a:sy n="95" d="100"/>
        </p:scale>
        <p:origin x="-882" y="264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045DBD-E603-464E-AEC2-46113673F892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FB88D7-DD66-461D-8C1F-730BA3CF19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55442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FB88D7-DD66-461D-8C1F-730BA3CF19F3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99232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247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457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288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920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614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251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408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992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943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666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246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266201-075A-4DD4-90C6-82411E26391B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A3FBF-59C8-475F-A5DD-DFC6F6FC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267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48" t="30925" r="448" b="993"/>
          <a:stretch/>
        </p:blipFill>
        <p:spPr>
          <a:xfrm>
            <a:off x="1331771" y="682517"/>
            <a:ext cx="2327364" cy="157806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2696" y="6747336"/>
            <a:ext cx="554461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 efficacy of crizotinib in a patient with lung adenocarcinoma harboring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ZR-ROS1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rearrangement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mpu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mography scans of Patien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 at baseline (February 11, 2019) (A), and tumo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sponse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t 6 months (September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19) of crizotinib therapy (B). C. Illustration of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he EZR-ROS1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rearrangement detected from the SLN-FNA sample of the patient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tegrated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ome Viewer screenshot showing the adjoining intron 10 of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ZR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t chromosome 6: 159,191,625 to intron 10 of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OS1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t chromosome 6:117,646,698, which retains the ROS1 intracellular tyrosine kinase domain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ach gray row represents the sequencing read from a DNA fragment. Bottom bar shows the DNA sequence annotation of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OS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left) and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Z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right)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C:\Users\anli.rao\AppData\Local\Temp\WeChat Files\1f13b983da46f65167c1433180537c3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1772" y="3934257"/>
            <a:ext cx="4458992" cy="26876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982161" y="61426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94255" y="225886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17261" y="380878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899"/>
          <a:stretch/>
        </p:blipFill>
        <p:spPr>
          <a:xfrm>
            <a:off x="3687919" y="680804"/>
            <a:ext cx="2102844" cy="1578064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281"/>
          <a:stretch/>
        </p:blipFill>
        <p:spPr>
          <a:xfrm>
            <a:off x="1336992" y="2329584"/>
            <a:ext cx="2322143" cy="1566384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422"/>
          <a:stretch/>
        </p:blipFill>
        <p:spPr>
          <a:xfrm>
            <a:off x="3687919" y="2331297"/>
            <a:ext cx="2117345" cy="15646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8153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33</Words>
  <Application>Microsoft Office PowerPoint</Application>
  <PresentationFormat>全屏显示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SCCM-CAS-S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饶安丽</dc:creator>
  <cp:lastModifiedBy>饶安丽</cp:lastModifiedBy>
  <cp:revision>27</cp:revision>
  <dcterms:created xsi:type="dcterms:W3CDTF">2019-12-20T09:21:25Z</dcterms:created>
  <dcterms:modified xsi:type="dcterms:W3CDTF">2020-08-03T03:29:05Z</dcterms:modified>
</cp:coreProperties>
</file>